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09200" cy="929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36960" cy="4636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71880" y="0"/>
            <a:ext cx="3036960" cy="4636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9760" cy="34876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0200" y="4416120"/>
            <a:ext cx="5610240" cy="4182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831160"/>
            <a:ext cx="3036960" cy="46368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71880" y="8831160"/>
            <a:ext cx="3036960" cy="46368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8760B69-A081-4249-850A-06C8F6AA218E}" type="slidenum"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9760" cy="3487680"/>
          </a:xfrm>
          <a:prstGeom prst="rect">
            <a:avLst/>
          </a:prstGeom>
          <a:ln w="0">
            <a:noFill/>
          </a:ln>
        </p:spPr>
      </p:sp>
      <p:sp>
        <p:nvSpPr>
          <p:cNvPr id="50" name="PlaceHolder 2"/>
          <p:cNvSpPr>
            <a:spLocks noGrp="1"/>
          </p:cNvSpPr>
          <p:nvPr>
            <p:ph type="body"/>
          </p:nvPr>
        </p:nvSpPr>
        <p:spPr>
          <a:xfrm>
            <a:off x="700200" y="4416120"/>
            <a:ext cx="561024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Slide Number Placeholder 3"/>
          <p:cNvSpPr/>
          <p:nvPr/>
        </p:nvSpPr>
        <p:spPr>
          <a:xfrm>
            <a:off x="3971880" y="8831160"/>
            <a:ext cx="3036960" cy="463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90483C1-33B0-446D-9777-F8E214BC1557}" type="slidenum"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C91947-639D-47EC-AA09-ADA827B6149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E0EADC-FA68-43F2-B76B-121F0B4832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5E1D75-2DC5-4BE5-ABF5-CF151D402EE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AA8326-F580-4F88-8FD6-A63798DBCD1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D1E45A-23D9-42C4-940F-1F4193C987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AB7364-98FE-4BE4-A9C8-B95829043A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A5BDB8-B890-4405-BB60-04470D4AEE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45193E-2BBC-4F7C-9FAC-E96B3DFE6F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820CC0-5675-4EF5-94C9-0B6DFE9200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4B89BA-448A-4AA2-B9CF-AD65371F5B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0FEBC0-9A55-41DB-A25A-5FFD88F726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5175F8-286F-4F0A-B30A-3D0C903B6F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B9E16D-4A70-4EDC-91CA-79B50C2FF9A9}" type="slidenum"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324000" y="1700280"/>
          <a:ext cx="8424720" cy="3438360"/>
        </p:xfrm>
        <a:graphic>
          <a:graphicData uri="http://schemas.openxmlformats.org/drawingml/2006/table">
            <a:tbl>
              <a:tblPr/>
              <a:tblGrid>
                <a:gridCol w="1008000"/>
                <a:gridCol w="1152360"/>
                <a:gridCol w="1079640"/>
                <a:gridCol w="1297080"/>
                <a:gridCol w="934920"/>
                <a:gridCol w="649080"/>
                <a:gridCol w="1008360"/>
                <a:gridCol w="1295280"/>
              </a:tblGrid>
              <a:tr h="639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Xenograft mode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lumetini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lumetini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%TG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osing  schedule per cycl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ytotoxi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%TG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 of cycl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eatment dur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mbination %TG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334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CT-1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mg/kg/bi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p.o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3**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rinoteca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mg/k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i.v once wkly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3*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 day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2**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931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W-6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.5mg/kg/bi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p.o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6**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mcitabin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5mg/k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i.p twice wkly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 day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2**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9334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Pc-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mg/kg/bi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p.o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2**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mcitabin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5mg/k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i.p twice wkly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.9*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 day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2**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2-22T13:53:33Z</dcterms:created>
  <dc:creator>Sarah Holt</dc:creator>
  <dc:description/>
  <dc:language>en-US</dc:language>
  <cp:lastModifiedBy>j.jagadheesh</cp:lastModifiedBy>
  <dcterms:modified xsi:type="dcterms:W3CDTF">2012-02-09T15:51:34Z</dcterms:modified>
  <cp:revision>338</cp:revision>
  <dc:subject/>
  <dc:title>PowerPoint Presentation</dc:title>
</cp:coreProperties>
</file>